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428" autoAdjust="0"/>
    <p:restoredTop sz="94660"/>
  </p:normalViewPr>
  <p:slideViewPr>
    <p:cSldViewPr snapToGrid="0">
      <p:cViewPr>
        <p:scale>
          <a:sx n="66" d="100"/>
          <a:sy n="66" d="100"/>
        </p:scale>
        <p:origin x="1709" y="39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A6D2BF-2804-3A5C-15A0-47A098A161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403074A-96C7-E270-0F80-FA610BA519E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5A5993-837F-4478-55A1-595BADD042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13C4D-F3C6-46AF-B3EE-05C812E6C512}" type="datetimeFigureOut">
              <a:rPr lang="en-US" smtClean="0"/>
              <a:t>7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1323E0-8E93-D126-3EDD-23411DC84F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1D3964-B969-3B8D-141A-630CE4A353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7EA37-F60E-4E85-8A10-D7EFDD03A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9363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060F2C-34E5-68A4-208C-1364A064F7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57A2347-5F5A-C5FD-7EFF-15322752A4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C11864-4674-D9FE-A302-5B25D22FEE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13C4D-F3C6-46AF-B3EE-05C812E6C512}" type="datetimeFigureOut">
              <a:rPr lang="en-US" smtClean="0"/>
              <a:t>7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1FBEDA-2A56-2202-47F3-7B29177FB3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211A23-7555-59A2-09EB-EAEE78A8EE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7EA37-F60E-4E85-8A10-D7EFDD03A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5534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0577366-E19E-37B2-2E31-D3838F8FE74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D65488-F86F-7AA9-AF31-045756BDA7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32925B-0441-95B9-C293-42EC775034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13C4D-F3C6-46AF-B3EE-05C812E6C512}" type="datetimeFigureOut">
              <a:rPr lang="en-US" smtClean="0"/>
              <a:t>7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824FF0-6001-9A27-BC67-FB2B5F5747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25DC84-707A-DD22-A171-23901E0957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7EA37-F60E-4E85-8A10-D7EFDD03A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26544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B973FD-08FF-A803-BF14-BFC239F862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48787F-4991-3E92-8BD9-92E4295F62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685631-23BE-4766-898B-D6DE3B9F17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13C4D-F3C6-46AF-B3EE-05C812E6C512}" type="datetimeFigureOut">
              <a:rPr lang="en-US" smtClean="0"/>
              <a:t>7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563BC9-8192-2A77-61DC-9E15C05B31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69A9EF-F4E5-E532-D497-71BFF12BDA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7EA37-F60E-4E85-8A10-D7EFDD03A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7144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BDE4A6-5A4F-137A-EAB0-1CA794CADB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9014B5-0E57-88CB-EA10-BC323E3055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BB677C-37C4-9B07-6855-BBCA3D417A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13C4D-F3C6-46AF-B3EE-05C812E6C512}" type="datetimeFigureOut">
              <a:rPr lang="en-US" smtClean="0"/>
              <a:t>7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6B970C-8361-18EF-8061-68D3CB5888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5A9951-9314-177E-EE04-F32E5FAC40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7EA37-F60E-4E85-8A10-D7EFDD03A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859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78885B-6307-B390-554C-56FA625B9A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29D8CB-7BF6-B71D-F8F9-5FED0F0409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148AA7-90FA-BFC2-DA89-A5B29891AB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2267C5-DF23-899F-C29F-EBBD0F29F8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13C4D-F3C6-46AF-B3EE-05C812E6C512}" type="datetimeFigureOut">
              <a:rPr lang="en-US" smtClean="0"/>
              <a:t>7/2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D6B4EC-4044-31CB-C77D-887D19AB2D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856044-80FE-D9EC-A7AB-1632C088FA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7EA37-F60E-4E85-8A10-D7EFDD03A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2618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BAFAA8-55B5-22B8-C42E-3B00C8DC7E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9DCAA0-37DB-E2B4-BA0B-1203E74956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63D2C8-0DEA-61FD-D92E-ED83433D24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3A883FF-747C-8F4A-F7E6-47C34C3C90B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A4757A7-B00B-587F-FA3C-536A0075FA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C4B9C60-2E72-3FB9-0BBA-136A73D16F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13C4D-F3C6-46AF-B3EE-05C812E6C512}" type="datetimeFigureOut">
              <a:rPr lang="en-US" smtClean="0"/>
              <a:t>7/2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1BC8396-A0C5-5040-F02D-CE023B2EF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18AF180-D979-CD82-55FE-DD0D15E3A2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7EA37-F60E-4E85-8A10-D7EFDD03A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8752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881B3B-33A8-A564-A8F3-3DDA0E8430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E3C5497-21EF-06DB-3166-E563984CB6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13C4D-F3C6-46AF-B3EE-05C812E6C512}" type="datetimeFigureOut">
              <a:rPr lang="en-US" smtClean="0"/>
              <a:t>7/2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68CCA0-608E-178F-0809-12A08CFF39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64A180A-54F5-7095-7ADA-052D9642C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7EA37-F60E-4E85-8A10-D7EFDD03A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43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5349E9A-BC68-F531-3274-83264AB032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13C4D-F3C6-46AF-B3EE-05C812E6C512}" type="datetimeFigureOut">
              <a:rPr lang="en-US" smtClean="0"/>
              <a:t>7/2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F2B4665-6975-823C-DF30-7A0FF67B74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DBF292B-F173-DD13-B5A2-9039129161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7EA37-F60E-4E85-8A10-D7EFDD03A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5563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C58975-CBC7-65B3-A5CB-CEE59D128A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B943B0-2957-3057-FA69-369590C888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8916DC2-AAAB-8A74-FABE-2DE7A92A4A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D8199A-4EF6-4837-6FC6-89DEAC26B4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13C4D-F3C6-46AF-B3EE-05C812E6C512}" type="datetimeFigureOut">
              <a:rPr lang="en-US" smtClean="0"/>
              <a:t>7/2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D5DDC4-2962-2CA3-2CA5-9BB1FD3A9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B5D6FB-73E6-AB89-BCBB-F341810834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7EA37-F60E-4E85-8A10-D7EFDD03A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6399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4DD9DA-1FDC-FE6D-CD26-39566C4183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425F238-62D3-243C-EF36-E06546AD675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7F095D-BA47-88E3-A037-1AA0F14C8E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F8F280-3CCA-FF7E-1DE5-EDFEF9C6A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13C4D-F3C6-46AF-B3EE-05C812E6C512}" type="datetimeFigureOut">
              <a:rPr lang="en-US" smtClean="0"/>
              <a:t>7/2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11FD7F-B8A1-84D7-4A07-3CCC424040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B8E2A4-ED6B-5B8A-B697-DA88F65A0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7EA37-F60E-4E85-8A10-D7EFDD03A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56419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E8C94E1-E6E2-E9A5-598B-A1BC35F267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D448BF-B389-1394-778E-D33BDBD48C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D2B0E3-CDBC-A71B-4B0E-531C57DBA3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A13C4D-F3C6-46AF-B3EE-05C812E6C512}" type="datetimeFigureOut">
              <a:rPr lang="en-US" smtClean="0"/>
              <a:t>7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7387B1-7509-57DF-958D-81FBFECAF2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9E9172-B757-C96B-0195-8A6095C7879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A7EA37-F60E-4E85-8A10-D7EFDD03A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3980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6F05D08-9A02-01EC-5149-2E0D853B2F8F}"/>
              </a:ext>
            </a:extLst>
          </p:cNvPr>
          <p:cNvSpPr txBox="1"/>
          <p:nvPr/>
        </p:nvSpPr>
        <p:spPr>
          <a:xfrm>
            <a:off x="422787" y="6213987"/>
            <a:ext cx="16419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aspase-1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B6AEDB9-6E2A-4B34-55AE-5832C88E932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63702" y="2291997"/>
            <a:ext cx="2816596" cy="227400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2281750-A265-1022-3A16-52444A9F18E3}"/>
              </a:ext>
            </a:extLst>
          </p:cNvPr>
          <p:cNvSpPr txBox="1"/>
          <p:nvPr/>
        </p:nvSpPr>
        <p:spPr>
          <a:xfrm>
            <a:off x="3618273" y="4080387"/>
            <a:ext cx="1809135" cy="3736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3676767" y="4610181"/>
            <a:ext cx="2058553" cy="25391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dirty="0">
                <a:cs typeface="+mj-cs"/>
              </a:rPr>
              <a:t>Normal   DCA    </a:t>
            </a:r>
            <a:r>
              <a:rPr lang="en-US" sz="1000" b="1" dirty="0" err="1">
                <a:cs typeface="+mj-cs"/>
              </a:rPr>
              <a:t>Oxaz</a:t>
            </a:r>
            <a:r>
              <a:rPr lang="en-US" sz="1000" b="1" dirty="0">
                <a:cs typeface="+mj-cs"/>
              </a:rPr>
              <a:t>   </a:t>
            </a:r>
            <a:r>
              <a:rPr lang="en-US" sz="1000" b="1" dirty="0" err="1">
                <a:cs typeface="+mj-cs"/>
              </a:rPr>
              <a:t>Oxaz+DCA</a:t>
            </a:r>
            <a:endParaRPr lang="ar-EG" b="1" dirty="0"/>
          </a:p>
        </p:txBody>
      </p:sp>
    </p:spTree>
    <p:extLst>
      <p:ext uri="{BB962C8B-B14F-4D97-AF65-F5344CB8AC3E}">
        <p14:creationId xmlns:p14="http://schemas.microsoft.com/office/powerpoint/2010/main" val="52731775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D71972D-52F1-50B7-E250-F52AC0303D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55150" y="1987171"/>
            <a:ext cx="2633700" cy="288365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E1678ED-957A-DCB2-052B-AE77F5CA79CC}"/>
              </a:ext>
            </a:extLst>
          </p:cNvPr>
          <p:cNvSpPr txBox="1"/>
          <p:nvPr/>
        </p:nvSpPr>
        <p:spPr>
          <a:xfrm>
            <a:off x="3743961" y="3044884"/>
            <a:ext cx="1701800" cy="3333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C52B7CE-A6F6-4602-C1EE-30889F9E758E}"/>
              </a:ext>
            </a:extLst>
          </p:cNvPr>
          <p:cNvSpPr txBox="1"/>
          <p:nvPr/>
        </p:nvSpPr>
        <p:spPr>
          <a:xfrm>
            <a:off x="422787" y="6213987"/>
            <a:ext cx="16419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uclear </a:t>
            </a:r>
            <a:r>
              <a:rPr lang="en-US" sz="16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F-</a:t>
            </a:r>
            <a:r>
              <a:rPr lang="en-US" sz="16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κB</a:t>
            </a:r>
            <a:r>
              <a:rPr lang="en-US" sz="16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82583C7-8FDF-27C2-83AA-99A3F3A4A11C}"/>
              </a:ext>
            </a:extLst>
          </p:cNvPr>
          <p:cNvSpPr txBox="1"/>
          <p:nvPr/>
        </p:nvSpPr>
        <p:spPr>
          <a:xfrm>
            <a:off x="3743961" y="3378200"/>
            <a:ext cx="2058553" cy="25391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dirty="0">
                <a:cs typeface="+mj-cs"/>
              </a:rPr>
              <a:t>Normal   DCA    </a:t>
            </a:r>
            <a:r>
              <a:rPr lang="en-US" sz="1000" b="1" dirty="0" err="1">
                <a:cs typeface="+mj-cs"/>
              </a:rPr>
              <a:t>Oxaz</a:t>
            </a:r>
            <a:r>
              <a:rPr lang="en-US" sz="1000" b="1" dirty="0">
                <a:cs typeface="+mj-cs"/>
              </a:rPr>
              <a:t>   </a:t>
            </a:r>
            <a:r>
              <a:rPr lang="en-US" sz="1000" b="1" dirty="0" err="1">
                <a:cs typeface="+mj-cs"/>
              </a:rPr>
              <a:t>Oxaz+DCA</a:t>
            </a:r>
            <a:endParaRPr lang="ar-EG" b="1" dirty="0"/>
          </a:p>
        </p:txBody>
      </p:sp>
    </p:spTree>
    <p:extLst>
      <p:ext uri="{BB962C8B-B14F-4D97-AF65-F5344CB8AC3E}">
        <p14:creationId xmlns:p14="http://schemas.microsoft.com/office/powerpoint/2010/main" val="394398339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B3257C5-2F99-FC50-37B9-CB8715DB7DDC}"/>
              </a:ext>
            </a:extLst>
          </p:cNvPr>
          <p:cNvSpPr txBox="1"/>
          <p:nvPr/>
        </p:nvSpPr>
        <p:spPr>
          <a:xfrm>
            <a:off x="422787" y="6213987"/>
            <a:ext cx="16419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NFATC1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C57740B-D17E-5F89-FED7-9ACD3BAAD6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24667" y="2200549"/>
            <a:ext cx="2694666" cy="245690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60DB675-9672-89B2-9DB7-9AC159ED68C1}"/>
              </a:ext>
            </a:extLst>
          </p:cNvPr>
          <p:cNvSpPr txBox="1"/>
          <p:nvPr/>
        </p:nvSpPr>
        <p:spPr>
          <a:xfrm>
            <a:off x="3916680" y="2418732"/>
            <a:ext cx="1759972" cy="2838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EB05A8A-D8F6-E2F2-1894-8B548FEA875A}"/>
              </a:ext>
            </a:extLst>
          </p:cNvPr>
          <p:cNvSpPr txBox="1"/>
          <p:nvPr/>
        </p:nvSpPr>
        <p:spPr>
          <a:xfrm>
            <a:off x="3885047" y="2669621"/>
            <a:ext cx="2058553" cy="25391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dirty="0">
                <a:cs typeface="+mj-cs"/>
              </a:rPr>
              <a:t>Normal   DCA    </a:t>
            </a:r>
            <a:r>
              <a:rPr lang="en-US" sz="1000" b="1" dirty="0" err="1">
                <a:cs typeface="+mj-cs"/>
              </a:rPr>
              <a:t>Oxaz</a:t>
            </a:r>
            <a:r>
              <a:rPr lang="en-US" sz="1000" b="1" dirty="0">
                <a:cs typeface="+mj-cs"/>
              </a:rPr>
              <a:t>   </a:t>
            </a:r>
            <a:r>
              <a:rPr lang="en-US" sz="1000" b="1" dirty="0" err="1">
                <a:cs typeface="+mj-cs"/>
              </a:rPr>
              <a:t>Oxaz+DCA</a:t>
            </a:r>
            <a:endParaRPr lang="ar-EG" b="1" dirty="0"/>
          </a:p>
        </p:txBody>
      </p:sp>
    </p:spTree>
    <p:extLst>
      <p:ext uri="{BB962C8B-B14F-4D97-AF65-F5344CB8AC3E}">
        <p14:creationId xmlns:p14="http://schemas.microsoft.com/office/powerpoint/2010/main" val="413225837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C01E7EF-3DC7-5353-67AE-5EA8C47AD0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29747" y="2200549"/>
            <a:ext cx="2694666" cy="245690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FD15CB6-0485-044F-C08B-5B07CE258AEC}"/>
              </a:ext>
            </a:extLst>
          </p:cNvPr>
          <p:cNvSpPr txBox="1"/>
          <p:nvPr/>
        </p:nvSpPr>
        <p:spPr>
          <a:xfrm>
            <a:off x="3774440" y="2464452"/>
            <a:ext cx="1798156" cy="2482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6E34649-CDB7-B42F-844C-7063BB98F17B}"/>
              </a:ext>
            </a:extLst>
          </p:cNvPr>
          <p:cNvSpPr txBox="1"/>
          <p:nvPr/>
        </p:nvSpPr>
        <p:spPr>
          <a:xfrm>
            <a:off x="422787" y="6213987"/>
            <a:ext cx="16419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NFATC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8953654-870B-34E0-5815-1B3AB951DF01}"/>
              </a:ext>
            </a:extLst>
          </p:cNvPr>
          <p:cNvSpPr txBox="1"/>
          <p:nvPr/>
        </p:nvSpPr>
        <p:spPr>
          <a:xfrm>
            <a:off x="3758047" y="2669621"/>
            <a:ext cx="2058553" cy="25391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dirty="0">
                <a:cs typeface="+mj-cs"/>
              </a:rPr>
              <a:t>Normal   DCA    </a:t>
            </a:r>
            <a:r>
              <a:rPr lang="en-US" sz="1000" b="1" dirty="0" err="1">
                <a:cs typeface="+mj-cs"/>
              </a:rPr>
              <a:t>Oxaz</a:t>
            </a:r>
            <a:r>
              <a:rPr lang="en-US" sz="1000" b="1" dirty="0">
                <a:cs typeface="+mj-cs"/>
              </a:rPr>
              <a:t>   </a:t>
            </a:r>
            <a:r>
              <a:rPr lang="en-US" sz="1000" b="1" dirty="0" err="1">
                <a:cs typeface="+mj-cs"/>
              </a:rPr>
              <a:t>Oxaz+DCA</a:t>
            </a:r>
            <a:endParaRPr lang="ar-EG" b="1" dirty="0"/>
          </a:p>
        </p:txBody>
      </p:sp>
    </p:spTree>
    <p:extLst>
      <p:ext uri="{BB962C8B-B14F-4D97-AF65-F5344CB8AC3E}">
        <p14:creationId xmlns:p14="http://schemas.microsoft.com/office/powerpoint/2010/main" val="71355870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A9CC4E2-D574-8D9C-BA5A-ECFBB53C62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21026" y="2017653"/>
            <a:ext cx="2901948" cy="282269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4C79829-9B18-B802-B8D0-49A86C6ABFF9}"/>
              </a:ext>
            </a:extLst>
          </p:cNvPr>
          <p:cNvSpPr txBox="1"/>
          <p:nvPr/>
        </p:nvSpPr>
        <p:spPr>
          <a:xfrm>
            <a:off x="3769360" y="2263382"/>
            <a:ext cx="1767840" cy="2410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3670B25-692A-6375-0AAB-468875E10D8F}"/>
              </a:ext>
            </a:extLst>
          </p:cNvPr>
          <p:cNvSpPr txBox="1"/>
          <p:nvPr/>
        </p:nvSpPr>
        <p:spPr>
          <a:xfrm>
            <a:off x="422787" y="6213987"/>
            <a:ext cx="16419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NFATC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91F6189-A436-BF7E-A2E1-3321E6189C7D}"/>
              </a:ext>
            </a:extLst>
          </p:cNvPr>
          <p:cNvSpPr txBox="1"/>
          <p:nvPr/>
        </p:nvSpPr>
        <p:spPr>
          <a:xfrm>
            <a:off x="3769360" y="2504440"/>
            <a:ext cx="2058553" cy="25391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dirty="0">
                <a:cs typeface="+mj-cs"/>
              </a:rPr>
              <a:t>Normal   DCA    </a:t>
            </a:r>
            <a:r>
              <a:rPr lang="en-US" sz="1000" b="1" dirty="0" err="1">
                <a:cs typeface="+mj-cs"/>
              </a:rPr>
              <a:t>Oxaz</a:t>
            </a:r>
            <a:r>
              <a:rPr lang="en-US" sz="1000" b="1" dirty="0">
                <a:cs typeface="+mj-cs"/>
              </a:rPr>
              <a:t>   </a:t>
            </a:r>
            <a:r>
              <a:rPr lang="en-US" sz="1000" b="1" dirty="0" err="1">
                <a:cs typeface="+mj-cs"/>
              </a:rPr>
              <a:t>Oxaz+DCA</a:t>
            </a:r>
            <a:endParaRPr lang="ar-EG" b="1" dirty="0"/>
          </a:p>
        </p:txBody>
      </p:sp>
    </p:spTree>
    <p:extLst>
      <p:ext uri="{BB962C8B-B14F-4D97-AF65-F5344CB8AC3E}">
        <p14:creationId xmlns:p14="http://schemas.microsoft.com/office/powerpoint/2010/main" val="322042925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E053A26-86FE-6C75-A5E7-CDD08ADDB0E2}"/>
              </a:ext>
            </a:extLst>
          </p:cNvPr>
          <p:cNvSpPr txBox="1"/>
          <p:nvPr/>
        </p:nvSpPr>
        <p:spPr>
          <a:xfrm>
            <a:off x="422787" y="6213987"/>
            <a:ext cx="16419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D7A7993-B8BD-EE44-D6EF-EED77C8C39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63702" y="2163970"/>
            <a:ext cx="2816596" cy="253005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89BA2F2-9E33-65AC-AEBB-5DED3B2899D1}"/>
              </a:ext>
            </a:extLst>
          </p:cNvPr>
          <p:cNvSpPr txBox="1"/>
          <p:nvPr/>
        </p:nvSpPr>
        <p:spPr>
          <a:xfrm>
            <a:off x="3721019" y="3293802"/>
            <a:ext cx="1858297" cy="3736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0676A86-1398-76E3-9652-8DD2CDF58F2A}"/>
              </a:ext>
            </a:extLst>
          </p:cNvPr>
          <p:cNvSpPr txBox="1"/>
          <p:nvPr/>
        </p:nvSpPr>
        <p:spPr>
          <a:xfrm>
            <a:off x="3736259" y="3667428"/>
            <a:ext cx="2058553" cy="25391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dirty="0">
                <a:cs typeface="+mj-cs"/>
              </a:rPr>
              <a:t>Normal   DCA    </a:t>
            </a:r>
            <a:r>
              <a:rPr lang="en-US" sz="1000" b="1" dirty="0" err="1">
                <a:cs typeface="+mj-cs"/>
              </a:rPr>
              <a:t>Oxaz</a:t>
            </a:r>
            <a:r>
              <a:rPr lang="en-US" sz="1000" b="1" dirty="0">
                <a:cs typeface="+mj-cs"/>
              </a:rPr>
              <a:t>   </a:t>
            </a:r>
            <a:r>
              <a:rPr lang="en-US" sz="1000" b="1" dirty="0" err="1">
                <a:cs typeface="+mj-cs"/>
              </a:rPr>
              <a:t>Oxaz+DCA</a:t>
            </a:r>
            <a:endParaRPr lang="ar-EG" b="1" dirty="0"/>
          </a:p>
        </p:txBody>
      </p:sp>
    </p:spTree>
    <p:extLst>
      <p:ext uri="{BB962C8B-B14F-4D97-AF65-F5344CB8AC3E}">
        <p14:creationId xmlns:p14="http://schemas.microsoft.com/office/powerpoint/2010/main" val="78810219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8BEF884-4861-3BE0-F529-CB73D25EE424}"/>
              </a:ext>
            </a:extLst>
          </p:cNvPr>
          <p:cNvSpPr txBox="1"/>
          <p:nvPr/>
        </p:nvSpPr>
        <p:spPr>
          <a:xfrm>
            <a:off x="422787" y="6213987"/>
            <a:ext cx="16419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C653947-4AAE-2D4E-922E-08F78E9196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33055" y="2045088"/>
            <a:ext cx="4852837" cy="2767824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2592888" y="2179529"/>
            <a:ext cx="1728592" cy="246762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ar-EG"/>
          </a:p>
        </p:txBody>
      </p:sp>
      <p:sp>
        <p:nvSpPr>
          <p:cNvPr id="9" name="Rectangle 8"/>
          <p:cNvSpPr/>
          <p:nvPr/>
        </p:nvSpPr>
        <p:spPr>
          <a:xfrm>
            <a:off x="4411246" y="2194143"/>
            <a:ext cx="1728592" cy="246762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ar-EG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4494D4D-F681-FF10-041D-E1FDADE79DE8}"/>
              </a:ext>
            </a:extLst>
          </p:cNvPr>
          <p:cNvSpPr txBox="1"/>
          <p:nvPr/>
        </p:nvSpPr>
        <p:spPr>
          <a:xfrm>
            <a:off x="2625174" y="3413342"/>
            <a:ext cx="2058553" cy="2308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900" b="1" dirty="0">
                <a:cs typeface="+mj-cs"/>
              </a:rPr>
              <a:t>Normal   DCA    </a:t>
            </a:r>
            <a:r>
              <a:rPr lang="en-US" sz="900" b="1" dirty="0" err="1">
                <a:cs typeface="+mj-cs"/>
              </a:rPr>
              <a:t>Oxaz</a:t>
            </a:r>
            <a:r>
              <a:rPr lang="en-US" sz="900" b="1" dirty="0">
                <a:cs typeface="+mj-cs"/>
              </a:rPr>
              <a:t>   </a:t>
            </a:r>
            <a:r>
              <a:rPr lang="en-US" sz="900" b="1" dirty="0" err="1">
                <a:cs typeface="+mj-cs"/>
              </a:rPr>
              <a:t>Oxaz+DCA</a:t>
            </a:r>
            <a:endParaRPr lang="ar-EG" sz="16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AA9A933-36D0-3949-BC97-06DC56C29183}"/>
              </a:ext>
            </a:extLst>
          </p:cNvPr>
          <p:cNvSpPr txBox="1"/>
          <p:nvPr/>
        </p:nvSpPr>
        <p:spPr>
          <a:xfrm>
            <a:off x="4451886" y="3408262"/>
            <a:ext cx="2058553" cy="2308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900" b="1" dirty="0">
                <a:cs typeface="+mj-cs"/>
              </a:rPr>
              <a:t>Normal   DCA    </a:t>
            </a:r>
            <a:r>
              <a:rPr lang="en-US" sz="900" b="1" dirty="0" err="1">
                <a:cs typeface="+mj-cs"/>
              </a:rPr>
              <a:t>Oxaz</a:t>
            </a:r>
            <a:r>
              <a:rPr lang="en-US" sz="900" b="1" dirty="0">
                <a:cs typeface="+mj-cs"/>
              </a:rPr>
              <a:t>   </a:t>
            </a:r>
            <a:r>
              <a:rPr lang="en-US" sz="900" b="1" dirty="0" err="1">
                <a:cs typeface="+mj-cs"/>
              </a:rPr>
              <a:t>Oxaz+DCA</a:t>
            </a:r>
            <a:endParaRPr lang="ar-EG" sz="16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5483BFA-0038-4702-BDCC-E820052C7565}"/>
              </a:ext>
            </a:extLst>
          </p:cNvPr>
          <p:cNvSpPr txBox="1"/>
          <p:nvPr/>
        </p:nvSpPr>
        <p:spPr>
          <a:xfrm>
            <a:off x="2625174" y="3144520"/>
            <a:ext cx="1606466" cy="284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C6D1897-451D-94CD-C9D1-857A0ED6BC7C}"/>
              </a:ext>
            </a:extLst>
          </p:cNvPr>
          <p:cNvSpPr txBox="1"/>
          <p:nvPr/>
        </p:nvSpPr>
        <p:spPr>
          <a:xfrm>
            <a:off x="4434764" y="3144520"/>
            <a:ext cx="1630756" cy="26374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47512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5871742-CA6E-3FB3-7ADB-A6D9B30383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63702" y="2209694"/>
            <a:ext cx="2816596" cy="243861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80A3A2A-1A24-2399-61CC-116FD2DA3EBB}"/>
              </a:ext>
            </a:extLst>
          </p:cNvPr>
          <p:cNvSpPr txBox="1"/>
          <p:nvPr/>
        </p:nvSpPr>
        <p:spPr>
          <a:xfrm>
            <a:off x="3618273" y="4080387"/>
            <a:ext cx="1809135" cy="3736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8A7AD9E-8AE0-EE85-F9DC-F32A7A3F7187}"/>
              </a:ext>
            </a:extLst>
          </p:cNvPr>
          <p:cNvSpPr txBox="1"/>
          <p:nvPr/>
        </p:nvSpPr>
        <p:spPr>
          <a:xfrm>
            <a:off x="422787" y="6213987"/>
            <a:ext cx="16419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aspase-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53C0C56-58A8-3AAA-EB70-57E1C6D10053}"/>
              </a:ext>
            </a:extLst>
          </p:cNvPr>
          <p:cNvSpPr txBox="1"/>
          <p:nvPr/>
        </p:nvSpPr>
        <p:spPr>
          <a:xfrm>
            <a:off x="3628433" y="4629439"/>
            <a:ext cx="2058553" cy="25391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dirty="0">
                <a:cs typeface="+mj-cs"/>
              </a:rPr>
              <a:t>Normal   DCA    </a:t>
            </a:r>
            <a:r>
              <a:rPr lang="en-US" sz="1000" b="1" dirty="0" err="1">
                <a:cs typeface="+mj-cs"/>
              </a:rPr>
              <a:t>Oxaz</a:t>
            </a:r>
            <a:r>
              <a:rPr lang="en-US" sz="1000" b="1" dirty="0">
                <a:cs typeface="+mj-cs"/>
              </a:rPr>
              <a:t>   </a:t>
            </a:r>
            <a:r>
              <a:rPr lang="en-US" sz="1000" b="1" dirty="0" err="1">
                <a:cs typeface="+mj-cs"/>
              </a:rPr>
              <a:t>Oxaz+DCA</a:t>
            </a:r>
            <a:endParaRPr lang="ar-EG" b="1" dirty="0"/>
          </a:p>
        </p:txBody>
      </p:sp>
    </p:spTree>
    <p:extLst>
      <p:ext uri="{BB962C8B-B14F-4D97-AF65-F5344CB8AC3E}">
        <p14:creationId xmlns:p14="http://schemas.microsoft.com/office/powerpoint/2010/main" val="23163596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FBE1D9C-139B-3C45-983C-24A2F607B5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81991" y="2194453"/>
            <a:ext cx="2780017" cy="246909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165CE45-0F69-CB3B-1FB5-DE2A22EB3262}"/>
              </a:ext>
            </a:extLst>
          </p:cNvPr>
          <p:cNvSpPr txBox="1"/>
          <p:nvPr/>
        </p:nvSpPr>
        <p:spPr>
          <a:xfrm>
            <a:off x="3618273" y="4129547"/>
            <a:ext cx="1809135" cy="3736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0671960-DCBD-86EF-4643-EA2D8553A584}"/>
              </a:ext>
            </a:extLst>
          </p:cNvPr>
          <p:cNvSpPr txBox="1"/>
          <p:nvPr/>
        </p:nvSpPr>
        <p:spPr>
          <a:xfrm>
            <a:off x="422787" y="6213987"/>
            <a:ext cx="16419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aspase-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9B3790D-9FE3-540E-8DAC-4862F99B3398}"/>
              </a:ext>
            </a:extLst>
          </p:cNvPr>
          <p:cNvSpPr txBox="1"/>
          <p:nvPr/>
        </p:nvSpPr>
        <p:spPr>
          <a:xfrm>
            <a:off x="3676767" y="4610181"/>
            <a:ext cx="2058553" cy="25391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dirty="0">
                <a:cs typeface="+mj-cs"/>
              </a:rPr>
              <a:t>Normal   DCA    </a:t>
            </a:r>
            <a:r>
              <a:rPr lang="en-US" sz="1000" b="1" dirty="0" err="1">
                <a:cs typeface="+mj-cs"/>
              </a:rPr>
              <a:t>Oxaz</a:t>
            </a:r>
            <a:r>
              <a:rPr lang="en-US" sz="1000" b="1" dirty="0">
                <a:cs typeface="+mj-cs"/>
              </a:rPr>
              <a:t>   </a:t>
            </a:r>
            <a:r>
              <a:rPr lang="en-US" sz="1000" b="1" dirty="0" err="1">
                <a:cs typeface="+mj-cs"/>
              </a:rPr>
              <a:t>Oxaz+DCA</a:t>
            </a:r>
            <a:endParaRPr lang="ar-EG" b="1" dirty="0"/>
          </a:p>
        </p:txBody>
      </p:sp>
    </p:spTree>
    <p:extLst>
      <p:ext uri="{BB962C8B-B14F-4D97-AF65-F5344CB8AC3E}">
        <p14:creationId xmlns:p14="http://schemas.microsoft.com/office/powerpoint/2010/main" val="33590192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645A187-E766-625B-1870-F9D0B3206E09}"/>
              </a:ext>
            </a:extLst>
          </p:cNvPr>
          <p:cNvSpPr txBox="1"/>
          <p:nvPr/>
        </p:nvSpPr>
        <p:spPr>
          <a:xfrm>
            <a:off x="422787" y="6213987"/>
            <a:ext cx="16419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LRP3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6DB7271-697D-27CE-EECC-EAD4176719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81991" y="2142632"/>
            <a:ext cx="2780017" cy="257273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885FA47-7D73-6987-535B-363F29D745C3}"/>
              </a:ext>
            </a:extLst>
          </p:cNvPr>
          <p:cNvSpPr txBox="1"/>
          <p:nvPr/>
        </p:nvSpPr>
        <p:spPr>
          <a:xfrm>
            <a:off x="3844416" y="2449735"/>
            <a:ext cx="1809135" cy="3736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B6DC75D-F601-7F8D-90C7-44609DE9E19E}"/>
              </a:ext>
            </a:extLst>
          </p:cNvPr>
          <p:cNvSpPr txBox="1"/>
          <p:nvPr/>
        </p:nvSpPr>
        <p:spPr>
          <a:xfrm>
            <a:off x="3844407" y="2857581"/>
            <a:ext cx="2058553" cy="25391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dirty="0">
                <a:cs typeface="+mj-cs"/>
              </a:rPr>
              <a:t>Normal   DCA    </a:t>
            </a:r>
            <a:r>
              <a:rPr lang="en-US" sz="1000" b="1" dirty="0" err="1">
                <a:cs typeface="+mj-cs"/>
              </a:rPr>
              <a:t>Oxaz</a:t>
            </a:r>
            <a:r>
              <a:rPr lang="en-US" sz="1000" b="1" dirty="0">
                <a:cs typeface="+mj-cs"/>
              </a:rPr>
              <a:t>   </a:t>
            </a:r>
            <a:r>
              <a:rPr lang="en-US" sz="1000" b="1" dirty="0" err="1">
                <a:cs typeface="+mj-cs"/>
              </a:rPr>
              <a:t>Oxaz+DCA</a:t>
            </a:r>
            <a:endParaRPr lang="ar-EG" b="1" dirty="0"/>
          </a:p>
        </p:txBody>
      </p:sp>
    </p:spTree>
    <p:extLst>
      <p:ext uri="{BB962C8B-B14F-4D97-AF65-F5344CB8AC3E}">
        <p14:creationId xmlns:p14="http://schemas.microsoft.com/office/powerpoint/2010/main" val="6228887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E9EDDFD-289F-0F79-3618-023039DB2F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9442" y="2056864"/>
            <a:ext cx="4365114" cy="2712955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2780778" y="2179529"/>
            <a:ext cx="1903956" cy="246762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ar-EG"/>
          </a:p>
        </p:txBody>
      </p:sp>
      <p:sp>
        <p:nvSpPr>
          <p:cNvPr id="9" name="Rectangle 8"/>
          <p:cNvSpPr/>
          <p:nvPr/>
        </p:nvSpPr>
        <p:spPr>
          <a:xfrm>
            <a:off x="4772410" y="2179529"/>
            <a:ext cx="1791228" cy="246762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ar-EG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80435A0-488B-07E7-E185-45025B75A49B}"/>
              </a:ext>
            </a:extLst>
          </p:cNvPr>
          <p:cNvSpPr txBox="1"/>
          <p:nvPr/>
        </p:nvSpPr>
        <p:spPr>
          <a:xfrm>
            <a:off x="422787" y="6213987"/>
            <a:ext cx="16419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LRP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335C764-208F-23DF-7C3D-57D822F3C515}"/>
              </a:ext>
            </a:extLst>
          </p:cNvPr>
          <p:cNvSpPr txBox="1"/>
          <p:nvPr/>
        </p:nvSpPr>
        <p:spPr>
          <a:xfrm>
            <a:off x="2825044" y="2333289"/>
            <a:ext cx="1657309" cy="3736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6AF3850-A032-EC59-40DE-E0A4A75DCB8D}"/>
              </a:ext>
            </a:extLst>
          </p:cNvPr>
          <p:cNvSpPr txBox="1"/>
          <p:nvPr/>
        </p:nvSpPr>
        <p:spPr>
          <a:xfrm>
            <a:off x="4787105" y="2323369"/>
            <a:ext cx="1520390" cy="3736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55B58FF-A813-F11B-878E-10D95599F52F}"/>
              </a:ext>
            </a:extLst>
          </p:cNvPr>
          <p:cNvSpPr txBox="1"/>
          <p:nvPr/>
        </p:nvSpPr>
        <p:spPr>
          <a:xfrm>
            <a:off x="2869047" y="2705181"/>
            <a:ext cx="2058553" cy="2308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900" b="1" dirty="0">
                <a:cs typeface="+mj-cs"/>
              </a:rPr>
              <a:t>Normal   DCA    </a:t>
            </a:r>
            <a:r>
              <a:rPr lang="en-US" sz="900" b="1" dirty="0" err="1">
                <a:cs typeface="+mj-cs"/>
              </a:rPr>
              <a:t>Oxaz</a:t>
            </a:r>
            <a:r>
              <a:rPr lang="en-US" sz="900" b="1" dirty="0">
                <a:cs typeface="+mj-cs"/>
              </a:rPr>
              <a:t>   </a:t>
            </a:r>
            <a:r>
              <a:rPr lang="en-US" sz="900" b="1" dirty="0" err="1">
                <a:cs typeface="+mj-cs"/>
              </a:rPr>
              <a:t>Oxaz+DCA</a:t>
            </a:r>
            <a:endParaRPr lang="ar-EG" sz="16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A0C9DCE-30C9-48CC-6C38-EE239BB4DDBD}"/>
              </a:ext>
            </a:extLst>
          </p:cNvPr>
          <p:cNvSpPr txBox="1"/>
          <p:nvPr/>
        </p:nvSpPr>
        <p:spPr>
          <a:xfrm>
            <a:off x="4728393" y="2691915"/>
            <a:ext cx="1903956" cy="2308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900" b="1" dirty="0">
                <a:cs typeface="+mj-cs"/>
              </a:rPr>
              <a:t>Normal   DCA    </a:t>
            </a:r>
            <a:r>
              <a:rPr lang="en-US" sz="900" b="1" dirty="0" err="1">
                <a:cs typeface="+mj-cs"/>
              </a:rPr>
              <a:t>Oxaz</a:t>
            </a:r>
            <a:r>
              <a:rPr lang="en-US" sz="900" b="1" dirty="0">
                <a:cs typeface="+mj-cs"/>
              </a:rPr>
              <a:t>   </a:t>
            </a:r>
            <a:r>
              <a:rPr lang="en-US" sz="900" b="1" dirty="0" err="1">
                <a:cs typeface="+mj-cs"/>
              </a:rPr>
              <a:t>Oxaz+DCA</a:t>
            </a:r>
            <a:endParaRPr lang="ar-EG" sz="1600" b="1" dirty="0"/>
          </a:p>
        </p:txBody>
      </p:sp>
    </p:spTree>
    <p:extLst>
      <p:ext uri="{BB962C8B-B14F-4D97-AF65-F5344CB8AC3E}">
        <p14:creationId xmlns:p14="http://schemas.microsoft.com/office/powerpoint/2010/main" val="35360339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7005EA3-E5E9-C9D4-C779-6775E7CCB194}"/>
              </a:ext>
            </a:extLst>
          </p:cNvPr>
          <p:cNvSpPr txBox="1"/>
          <p:nvPr/>
        </p:nvSpPr>
        <p:spPr>
          <a:xfrm>
            <a:off x="422787" y="6213987"/>
            <a:ext cx="16419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en-US" sz="16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F-</a:t>
            </a:r>
            <a:r>
              <a:rPr lang="en-US" sz="16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κB</a:t>
            </a:r>
            <a:r>
              <a:rPr lang="en-US" sz="16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C5DFC34-6F57-FADC-3013-1A81A05800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12474" y="2237128"/>
            <a:ext cx="2719052" cy="238374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5B96AC4-0B39-C8ED-F1EE-8B714DD473D9}"/>
              </a:ext>
            </a:extLst>
          </p:cNvPr>
          <p:cNvSpPr txBox="1"/>
          <p:nvPr/>
        </p:nvSpPr>
        <p:spPr>
          <a:xfrm>
            <a:off x="3667432" y="2959508"/>
            <a:ext cx="1809135" cy="3736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16EA91E-7BE6-6DBB-7903-0B37902ED26E}"/>
              </a:ext>
            </a:extLst>
          </p:cNvPr>
          <p:cNvSpPr txBox="1"/>
          <p:nvPr/>
        </p:nvSpPr>
        <p:spPr>
          <a:xfrm>
            <a:off x="3667432" y="3333134"/>
            <a:ext cx="2058553" cy="25391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dirty="0">
                <a:cs typeface="+mj-cs"/>
              </a:rPr>
              <a:t>Normal   DCA    </a:t>
            </a:r>
            <a:r>
              <a:rPr lang="en-US" sz="1000" b="1" dirty="0" err="1">
                <a:cs typeface="+mj-cs"/>
              </a:rPr>
              <a:t>Oxaz</a:t>
            </a:r>
            <a:r>
              <a:rPr lang="en-US" sz="1000" b="1" dirty="0">
                <a:cs typeface="+mj-cs"/>
              </a:rPr>
              <a:t>   </a:t>
            </a:r>
            <a:r>
              <a:rPr lang="en-US" sz="1000" b="1" dirty="0" err="1">
                <a:cs typeface="+mj-cs"/>
              </a:rPr>
              <a:t>Oxaz+DCA</a:t>
            </a:r>
            <a:endParaRPr lang="ar-EG" b="1" dirty="0"/>
          </a:p>
        </p:txBody>
      </p:sp>
    </p:spTree>
    <p:extLst>
      <p:ext uri="{BB962C8B-B14F-4D97-AF65-F5344CB8AC3E}">
        <p14:creationId xmlns:p14="http://schemas.microsoft.com/office/powerpoint/2010/main" val="5505700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8D39E81-C723-BC2C-09A4-673A1B77D1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12474" y="2142632"/>
            <a:ext cx="2719052" cy="257273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25353A4-235E-6844-9E78-A2C96834B700}"/>
              </a:ext>
            </a:extLst>
          </p:cNvPr>
          <p:cNvSpPr txBox="1"/>
          <p:nvPr/>
        </p:nvSpPr>
        <p:spPr>
          <a:xfrm>
            <a:off x="3814753" y="2913788"/>
            <a:ext cx="1747848" cy="3736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11F5A49-87C5-E745-E1F2-0CAD31369CD7}"/>
              </a:ext>
            </a:extLst>
          </p:cNvPr>
          <p:cNvSpPr txBox="1"/>
          <p:nvPr/>
        </p:nvSpPr>
        <p:spPr>
          <a:xfrm>
            <a:off x="422787" y="6213987"/>
            <a:ext cx="16419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en-US" sz="16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F-</a:t>
            </a:r>
            <a:r>
              <a:rPr lang="en-US" sz="16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κB</a:t>
            </a:r>
            <a:r>
              <a:rPr lang="en-US" sz="16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6BCA109-473F-09F8-8126-F901481DE689}"/>
              </a:ext>
            </a:extLst>
          </p:cNvPr>
          <p:cNvSpPr txBox="1"/>
          <p:nvPr/>
        </p:nvSpPr>
        <p:spPr>
          <a:xfrm>
            <a:off x="3747887" y="3302041"/>
            <a:ext cx="2058553" cy="25391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dirty="0">
                <a:cs typeface="+mj-cs"/>
              </a:rPr>
              <a:t>Normal   DCA    </a:t>
            </a:r>
            <a:r>
              <a:rPr lang="en-US" sz="1000" b="1" dirty="0" err="1">
                <a:cs typeface="+mj-cs"/>
              </a:rPr>
              <a:t>Oxaz</a:t>
            </a:r>
            <a:r>
              <a:rPr lang="en-US" sz="1000" b="1" dirty="0">
                <a:cs typeface="+mj-cs"/>
              </a:rPr>
              <a:t>   </a:t>
            </a:r>
            <a:r>
              <a:rPr lang="en-US" sz="1000" b="1" dirty="0" err="1">
                <a:cs typeface="+mj-cs"/>
              </a:rPr>
              <a:t>Oxaz+DCA</a:t>
            </a:r>
            <a:endParaRPr lang="ar-EG" b="1" dirty="0"/>
          </a:p>
        </p:txBody>
      </p:sp>
    </p:spTree>
    <p:extLst>
      <p:ext uri="{BB962C8B-B14F-4D97-AF65-F5344CB8AC3E}">
        <p14:creationId xmlns:p14="http://schemas.microsoft.com/office/powerpoint/2010/main" val="1423169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398D6D1-C6C6-252F-04B8-286D36F351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14929" y="2164987"/>
            <a:ext cx="2914141" cy="251786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D1896E6-E6CC-D306-074E-BB913D26F70C}"/>
              </a:ext>
            </a:extLst>
          </p:cNvPr>
          <p:cNvSpPr txBox="1"/>
          <p:nvPr/>
        </p:nvSpPr>
        <p:spPr>
          <a:xfrm>
            <a:off x="3708072" y="2934108"/>
            <a:ext cx="1858297" cy="3736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BB9B7C7-8D55-F7CD-E386-BD1B7A37DF5E}"/>
              </a:ext>
            </a:extLst>
          </p:cNvPr>
          <p:cNvSpPr txBox="1"/>
          <p:nvPr/>
        </p:nvSpPr>
        <p:spPr>
          <a:xfrm>
            <a:off x="422787" y="6213987"/>
            <a:ext cx="16419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en-US" sz="16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F-</a:t>
            </a:r>
            <a:r>
              <a:rPr lang="en-US" sz="16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κB</a:t>
            </a:r>
            <a:r>
              <a:rPr lang="en-US" sz="16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D54F38F-73B9-CECC-0097-5D5BDE42FBD0}"/>
              </a:ext>
            </a:extLst>
          </p:cNvPr>
          <p:cNvSpPr txBox="1"/>
          <p:nvPr/>
        </p:nvSpPr>
        <p:spPr>
          <a:xfrm>
            <a:off x="3753792" y="3302654"/>
            <a:ext cx="2058553" cy="25391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dirty="0">
                <a:cs typeface="+mj-cs"/>
              </a:rPr>
              <a:t>Normal   DCA    </a:t>
            </a:r>
            <a:r>
              <a:rPr lang="en-US" sz="1000" b="1" dirty="0" err="1">
                <a:cs typeface="+mj-cs"/>
              </a:rPr>
              <a:t>Oxaz</a:t>
            </a:r>
            <a:r>
              <a:rPr lang="en-US" sz="1000" b="1" dirty="0">
                <a:cs typeface="+mj-cs"/>
              </a:rPr>
              <a:t>   </a:t>
            </a:r>
            <a:r>
              <a:rPr lang="en-US" sz="1000" b="1" dirty="0" err="1">
                <a:cs typeface="+mj-cs"/>
              </a:rPr>
              <a:t>Oxaz+DCA</a:t>
            </a:r>
            <a:endParaRPr lang="ar-EG" b="1" dirty="0"/>
          </a:p>
        </p:txBody>
      </p:sp>
    </p:spTree>
    <p:extLst>
      <p:ext uri="{BB962C8B-B14F-4D97-AF65-F5344CB8AC3E}">
        <p14:creationId xmlns:p14="http://schemas.microsoft.com/office/powerpoint/2010/main" val="102220839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3F64AF2-C9AE-7BD5-98D8-B106E12392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65056" y="2096908"/>
            <a:ext cx="4413887" cy="2664183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2680570" y="2179529"/>
            <a:ext cx="1728592" cy="246762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ar-EG"/>
          </a:p>
        </p:txBody>
      </p:sp>
      <p:sp>
        <p:nvSpPr>
          <p:cNvPr id="9" name="Rectangle 8"/>
          <p:cNvSpPr/>
          <p:nvPr/>
        </p:nvSpPr>
        <p:spPr>
          <a:xfrm>
            <a:off x="4523980" y="2181617"/>
            <a:ext cx="1728592" cy="246762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ar-EG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ED156FB-0842-A8A6-7887-40E6A3B95C7F}"/>
              </a:ext>
            </a:extLst>
          </p:cNvPr>
          <p:cNvSpPr txBox="1"/>
          <p:nvPr/>
        </p:nvSpPr>
        <p:spPr>
          <a:xfrm>
            <a:off x="292158" y="6176190"/>
            <a:ext cx="16419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uclear </a:t>
            </a:r>
            <a:r>
              <a:rPr lang="en-US" sz="16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F-</a:t>
            </a:r>
            <a:r>
              <a:rPr lang="en-US" sz="16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κB</a:t>
            </a:r>
            <a:r>
              <a:rPr lang="en-US" sz="16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099B56D-DB6E-4465-A824-80ABCEE276A8}"/>
              </a:ext>
            </a:extLst>
          </p:cNvPr>
          <p:cNvSpPr txBox="1"/>
          <p:nvPr/>
        </p:nvSpPr>
        <p:spPr>
          <a:xfrm>
            <a:off x="3015039" y="2825731"/>
            <a:ext cx="1353762" cy="2910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96DD626-8C50-98D9-2A79-C41DEE2D0E91}"/>
              </a:ext>
            </a:extLst>
          </p:cNvPr>
          <p:cNvSpPr txBox="1"/>
          <p:nvPr/>
        </p:nvSpPr>
        <p:spPr>
          <a:xfrm>
            <a:off x="4595263" y="2788920"/>
            <a:ext cx="1394057" cy="297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95F1D9C-4E36-0144-2DFE-1AECFF03FADA}"/>
              </a:ext>
            </a:extLst>
          </p:cNvPr>
          <p:cNvSpPr txBox="1"/>
          <p:nvPr/>
        </p:nvSpPr>
        <p:spPr>
          <a:xfrm>
            <a:off x="2968332" y="3116736"/>
            <a:ext cx="2058553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800" b="1" dirty="0">
                <a:cs typeface="+mj-cs"/>
              </a:rPr>
              <a:t>Normal   DCA    </a:t>
            </a:r>
            <a:r>
              <a:rPr lang="en-US" sz="800" b="1" dirty="0" err="1">
                <a:cs typeface="+mj-cs"/>
              </a:rPr>
              <a:t>Oxaz</a:t>
            </a:r>
            <a:r>
              <a:rPr lang="en-US" sz="800" b="1" dirty="0">
                <a:cs typeface="+mj-cs"/>
              </a:rPr>
              <a:t>   </a:t>
            </a:r>
            <a:r>
              <a:rPr lang="en-US" sz="800" b="1" dirty="0" err="1">
                <a:cs typeface="+mj-cs"/>
              </a:rPr>
              <a:t>Oxaz+DCA</a:t>
            </a:r>
            <a:endParaRPr lang="ar-EG" sz="14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66E24E6-2C96-7ACF-0626-C99946D02423}"/>
              </a:ext>
            </a:extLst>
          </p:cNvPr>
          <p:cNvSpPr txBox="1"/>
          <p:nvPr/>
        </p:nvSpPr>
        <p:spPr>
          <a:xfrm>
            <a:off x="4595100" y="3107924"/>
            <a:ext cx="2058553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800" b="1" dirty="0">
                <a:cs typeface="+mj-cs"/>
              </a:rPr>
              <a:t>Normal   DCA    </a:t>
            </a:r>
            <a:r>
              <a:rPr lang="en-US" sz="800" b="1" dirty="0" err="1">
                <a:cs typeface="+mj-cs"/>
              </a:rPr>
              <a:t>Oxaz</a:t>
            </a:r>
            <a:r>
              <a:rPr lang="en-US" sz="800" b="1" dirty="0">
                <a:cs typeface="+mj-cs"/>
              </a:rPr>
              <a:t>   </a:t>
            </a:r>
            <a:r>
              <a:rPr lang="en-US" sz="800" b="1" dirty="0" err="1">
                <a:cs typeface="+mj-cs"/>
              </a:rPr>
              <a:t>Oxaz+DCA</a:t>
            </a:r>
            <a:endParaRPr lang="ar-EG" sz="1400" b="1" dirty="0"/>
          </a:p>
        </p:txBody>
      </p:sp>
    </p:spTree>
    <p:extLst>
      <p:ext uri="{BB962C8B-B14F-4D97-AF65-F5344CB8AC3E}">
        <p14:creationId xmlns:p14="http://schemas.microsoft.com/office/powerpoint/2010/main" val="2287733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8</TotalTime>
  <Words>130</Words>
  <Application>Microsoft Office PowerPoint</Application>
  <PresentationFormat>On-screen Show (4:3)</PresentationFormat>
  <Paragraphs>33</Paragraphs>
  <Slides>1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res El-sayed Mohamed Aly</dc:creator>
  <cp:lastModifiedBy>Amany Azoouz</cp:lastModifiedBy>
  <cp:revision>20</cp:revision>
  <dcterms:created xsi:type="dcterms:W3CDTF">2022-10-09T17:58:03Z</dcterms:created>
  <dcterms:modified xsi:type="dcterms:W3CDTF">2023-07-21T07:38:52Z</dcterms:modified>
</cp:coreProperties>
</file>